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04" r:id="rId2"/>
    <p:sldId id="302" r:id="rId3"/>
    <p:sldId id="303" r:id="rId4"/>
    <p:sldId id="300" r:id="rId5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Μεσαίο στυλ 2 - Έμφαση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11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D61424-FB61-43F1-8245-39D62039B16E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33CB8-A79D-47D1-9692-88363D082E2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6146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33CB8-A79D-47D1-9692-88363D082E23}" type="slidenum">
              <a:rPr lang="el-GR" smtClean="0"/>
              <a:t>2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91109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BB9AA377-1E27-D234-583E-2515BC5B27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3AACA819-06F1-8CB7-98EA-5A9A4DDA3C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08BEED4-E262-9E9D-9E1E-B2EDBF3A4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A4EBB912-0B84-47E3-AB09-D3FA4DE19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A8E015A0-B7C3-17F0-B62B-EA582F514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58091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1CA74EA-AF9D-3952-D63F-331F015385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38C74BC4-2EE3-4ADB-CA71-AD1D040C62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3E20F28E-C2D1-8764-7FE3-EF59DE7A9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61C0C585-8F55-BB50-7A01-A1F564D46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4C46B097-A29F-14B5-715D-7D226064C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80665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BF71DF3D-18C0-76DC-F114-FEF41B3A47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C0026675-15F1-0FAD-9CF7-FAE7A65363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565F728E-D88F-E261-E07B-469E4F18F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8BD79D50-5CDD-E7D0-E2B9-4F840E13F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26BBFA99-3FA7-1845-C8AA-5FEFBEAEE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9921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AFE26006-8579-420D-C382-9B80710B4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380D0E66-25AB-3EB8-3980-2640751300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BE664540-2C79-218D-6327-FF790BA08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6B32C871-CBE8-4D1A-01AE-2578510AF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C2B61B74-3ABB-1C25-A3AA-BDC941BB1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60343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0B72C687-258E-79A4-3951-2700C5B5B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FA4143F0-C413-0C1C-FF82-245F78CE90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07AEE973-CC2E-3682-7816-8A66A97BC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992E60AC-0083-FAC9-F330-9F38EBCEC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DC5DC79F-5C18-C78C-9F98-3073D30F0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29751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6CD2374-462D-FAD5-507C-9E51FF3D2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4C8564F3-F2DC-BB01-81C5-CA2A1E46DF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E9CF3C60-30A4-DBFA-B7A6-6D9CB7775B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9974D6CC-0096-0AA4-4636-4A30165F6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28DD8AE3-AA09-21A4-FD13-DE891EBF1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BD589A0C-9FAB-A74B-295F-B921E4395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33232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999FB5E4-5A1B-9AF2-46F6-ABCCFC6C7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526074EC-87FA-FC56-311E-E2B09C78E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CAE51936-32B0-3C07-6AAE-C0200FE9E5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2BDFC86D-7E82-DD6E-33B4-DE376F1AC4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FFFC652F-6032-786E-6954-1151189399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1D801D6B-AFAB-B81F-9B14-CFC2EB37B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63302F89-4E10-F924-DA27-63C03FC52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41F4A6DE-A0A0-2355-ECD0-721AC41E0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0240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8E0F5F25-CA66-5B90-2CE8-E90734FED8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E3E3C09C-1899-3E0A-932C-9B888F73E6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474056A8-A92C-B7AD-AE2E-374999723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00A474B9-C995-B61F-A401-E3A52DDF4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07155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80A631DE-107F-611A-8C58-17A933692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7FDA3072-5362-D791-2DA4-84BD857A3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B203AB50-E6D8-81FB-0D29-AD911707C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89724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F756DB7-7A6C-4847-07C0-395CA5A7D2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2964C67A-4E60-68C0-3627-BDA0B2252F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28B32983-5141-2E25-CCBA-02F6109E0D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0C158C0E-293B-16B4-2F70-690A0EC48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48C66438-2531-C1C0-DB88-D8150D07F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C24E4551-1F81-8CDA-CCBC-5F34C843D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52132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2DC6A85C-4FA5-D393-B89F-83F2C1622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F08590F9-5EF5-9F7D-2079-92FFFB3083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FCCEB912-7CC3-34AB-FEC6-0259D212A3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C4F8AD1F-F2DC-F3B2-B636-05397F14B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83A09885-83D5-58E9-FD13-B64C3AF53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F5F996D4-EC11-768B-E4BA-8456CCE28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5008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BF4804BD-9B5C-CE36-D691-8E356BCDC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6FCF058A-B8D1-243A-E15B-9DF9F0FE51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7A3EA9E2-4F34-4804-F5AD-F0CDEC7E5D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A04DE2-3F9E-4484-83DE-94730F005D33}" type="datetimeFigureOut">
              <a:rPr lang="el-GR" smtClean="0"/>
              <a:t>18/1/2026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F663EAC9-E36E-75FD-16AD-F8AF74B8C7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CA7B8844-5BA4-B6DB-B6C6-A33909C85A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14916A-22C5-474A-B745-B165CD7FECE1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92840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73744C8D-5B04-2156-EE05-9F9347E57514}"/>
              </a:ext>
            </a:extLst>
          </p:cNvPr>
          <p:cNvSpPr txBox="1"/>
          <p:nvPr/>
        </p:nvSpPr>
        <p:spPr>
          <a:xfrm>
            <a:off x="1580608" y="27212"/>
            <a:ext cx="65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l-GR" b="1" dirty="0"/>
          </a:p>
        </p:txBody>
      </p:sp>
      <p:grpSp>
        <p:nvGrpSpPr>
          <p:cNvPr id="47" name="Ομάδα 46">
            <a:extLst>
              <a:ext uri="{FF2B5EF4-FFF2-40B4-BE49-F238E27FC236}">
                <a16:creationId xmlns:a16="http://schemas.microsoft.com/office/drawing/2014/main" id="{FEA3FE0C-0C49-22BD-B88F-34A69640AA44}"/>
              </a:ext>
            </a:extLst>
          </p:cNvPr>
          <p:cNvGrpSpPr/>
          <p:nvPr/>
        </p:nvGrpSpPr>
        <p:grpSpPr>
          <a:xfrm>
            <a:off x="1773611" y="113914"/>
            <a:ext cx="9537355" cy="6720367"/>
            <a:chOff x="1773611" y="113914"/>
            <a:chExt cx="9537355" cy="6720367"/>
          </a:xfrm>
        </p:grpSpPr>
        <p:grpSp>
          <p:nvGrpSpPr>
            <p:cNvPr id="48" name="Ομάδα 47">
              <a:extLst>
                <a:ext uri="{FF2B5EF4-FFF2-40B4-BE49-F238E27FC236}">
                  <a16:creationId xmlns:a16="http://schemas.microsoft.com/office/drawing/2014/main" id="{DFAAB417-0CD7-4D49-5EA9-6960C8DDA2AF}"/>
                </a:ext>
              </a:extLst>
            </p:cNvPr>
            <p:cNvGrpSpPr/>
            <p:nvPr/>
          </p:nvGrpSpPr>
          <p:grpSpPr>
            <a:xfrm>
              <a:off x="1773611" y="238394"/>
              <a:ext cx="9537355" cy="6595887"/>
              <a:chOff x="1773611" y="325482"/>
              <a:chExt cx="9537355" cy="6595887"/>
            </a:xfrm>
          </p:grpSpPr>
          <p:grpSp>
            <p:nvGrpSpPr>
              <p:cNvPr id="50" name="Ομάδα 49">
                <a:extLst>
                  <a:ext uri="{FF2B5EF4-FFF2-40B4-BE49-F238E27FC236}">
                    <a16:creationId xmlns:a16="http://schemas.microsoft.com/office/drawing/2014/main" id="{80F1CC73-83FA-F5F0-7165-91964BC86322}"/>
                  </a:ext>
                </a:extLst>
              </p:cNvPr>
              <p:cNvGrpSpPr/>
              <p:nvPr/>
            </p:nvGrpSpPr>
            <p:grpSpPr>
              <a:xfrm>
                <a:off x="1818384" y="325482"/>
                <a:ext cx="8555231" cy="6324683"/>
                <a:chOff x="1633798" y="134592"/>
                <a:chExt cx="8924404" cy="6612362"/>
              </a:xfrm>
            </p:grpSpPr>
            <p:pic>
              <p:nvPicPr>
                <p:cNvPr id="60" name="Εικόνα 59" descr="Εικόνα που περιέχει κείμενο, διάγραμμα, παράλληλα, γραμμή&#10;&#10;Το περιεχόμενο που δημιουργείται από AI ενδέχεται να είναι εσφαλμένο.">
                  <a:extLst>
                    <a:ext uri="{FF2B5EF4-FFF2-40B4-BE49-F238E27FC236}">
                      <a16:creationId xmlns:a16="http://schemas.microsoft.com/office/drawing/2014/main" id="{48805FB0-1D02-9ED0-F736-FC8EFD92F48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633798" y="134592"/>
                  <a:ext cx="8924404" cy="6588816"/>
                </a:xfrm>
                <a:prstGeom prst="rect">
                  <a:avLst/>
                </a:prstGeom>
              </p:spPr>
            </p:pic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6249438D-B480-0CF7-A915-CE8364E14713}"/>
                    </a:ext>
                  </a:extLst>
                </p:cNvPr>
                <p:cNvSpPr txBox="1"/>
                <p:nvPr/>
              </p:nvSpPr>
              <p:spPr>
                <a:xfrm>
                  <a:off x="2235640" y="6448287"/>
                  <a:ext cx="870865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B cells</a:t>
                  </a:r>
                  <a:endParaRPr lang="el-GR" sz="1200" dirty="0"/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4FAFF3BB-83D5-B69E-035C-C5902737D34E}"/>
                    </a:ext>
                  </a:extLst>
                </p:cNvPr>
                <p:cNvSpPr txBox="1"/>
                <p:nvPr/>
              </p:nvSpPr>
              <p:spPr>
                <a:xfrm>
                  <a:off x="8572106" y="6446471"/>
                  <a:ext cx="859435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T cells</a:t>
                  </a:r>
                  <a:endParaRPr lang="el-GR" sz="1200" dirty="0"/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2BE2670D-026E-37A2-BC1D-AED1066F0A4E}"/>
                    </a:ext>
                  </a:extLst>
                </p:cNvPr>
                <p:cNvSpPr txBox="1"/>
                <p:nvPr/>
              </p:nvSpPr>
              <p:spPr>
                <a:xfrm>
                  <a:off x="7204664" y="6457356"/>
                  <a:ext cx="1255763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Plasma Cells</a:t>
                  </a:r>
                  <a:endParaRPr lang="el-GR" sz="1200" dirty="0"/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42FA6D67-55B6-2282-E98A-6CDC649273E6}"/>
                    </a:ext>
                  </a:extLst>
                </p:cNvPr>
                <p:cNvSpPr txBox="1"/>
                <p:nvPr/>
              </p:nvSpPr>
              <p:spPr>
                <a:xfrm>
                  <a:off x="3354607" y="6449835"/>
                  <a:ext cx="660085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CAFs</a:t>
                  </a:r>
                  <a:endParaRPr lang="el-GR" sz="1200" dirty="0"/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0A05FB9C-0B93-8008-6696-7A6218D333BA}"/>
                    </a:ext>
                  </a:extLst>
                </p:cNvPr>
                <p:cNvSpPr txBox="1"/>
                <p:nvPr/>
              </p:nvSpPr>
              <p:spPr>
                <a:xfrm>
                  <a:off x="4043070" y="6446470"/>
                  <a:ext cx="1270612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Ciliated cells</a:t>
                  </a:r>
                  <a:endParaRPr lang="el-GR" sz="1200" dirty="0"/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2ADEE8D4-44A7-458C-FF70-93B0B594C0C3}"/>
                    </a:ext>
                  </a:extLst>
                </p:cNvPr>
                <p:cNvSpPr txBox="1"/>
                <p:nvPr/>
              </p:nvSpPr>
              <p:spPr>
                <a:xfrm>
                  <a:off x="6217441" y="6447894"/>
                  <a:ext cx="1171180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Myeloid</a:t>
                  </a:r>
                  <a:endParaRPr lang="el-GR" sz="1200" dirty="0"/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FB18AB30-CA79-534C-C182-20759B740E57}"/>
                    </a:ext>
                  </a:extLst>
                </p:cNvPr>
                <p:cNvSpPr txBox="1"/>
                <p:nvPr/>
              </p:nvSpPr>
              <p:spPr>
                <a:xfrm>
                  <a:off x="5181651" y="6457356"/>
                  <a:ext cx="1171180" cy="28959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Mast Cells</a:t>
                  </a:r>
                  <a:endParaRPr lang="el-GR" sz="1200" dirty="0"/>
                </a:p>
              </p:txBody>
            </p:sp>
          </p:grp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75E61E6E-96AD-A7CC-F554-90474911C47C}"/>
                  </a:ext>
                </a:extLst>
              </p:cNvPr>
              <p:cNvSpPr txBox="1"/>
              <p:nvPr/>
            </p:nvSpPr>
            <p:spPr>
              <a:xfrm>
                <a:off x="5406041" y="6613592"/>
                <a:ext cx="87047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/>
                  <a:t>Identity</a:t>
                </a:r>
                <a:endParaRPr lang="el-GR" sz="1400" b="1" dirty="0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309DD448-A005-7C0C-F3EA-7247C01436F0}"/>
                  </a:ext>
                </a:extLst>
              </p:cNvPr>
              <p:cNvSpPr txBox="1"/>
              <p:nvPr/>
            </p:nvSpPr>
            <p:spPr>
              <a:xfrm rot="16200000">
                <a:off x="1093129" y="3173311"/>
                <a:ext cx="166874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/>
                  <a:t>Expression Level</a:t>
                </a:r>
                <a:endParaRPr lang="el-GR" sz="1400" b="1" dirty="0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4FD3517A-93CA-DEDC-BB64-23CF84F2DE9F}"/>
                  </a:ext>
                </a:extLst>
              </p:cNvPr>
              <p:cNvSpPr txBox="1"/>
              <p:nvPr/>
            </p:nvSpPr>
            <p:spPr>
              <a:xfrm>
                <a:off x="9772478" y="3823867"/>
                <a:ext cx="727892" cy="216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T cells</a:t>
                </a:r>
                <a:endParaRPr lang="el-GR" sz="1200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ED3DD1CC-4CBB-133D-E6E9-EDAB102BFF4B}"/>
                  </a:ext>
                </a:extLst>
              </p:cNvPr>
              <p:cNvSpPr txBox="1"/>
              <p:nvPr/>
            </p:nvSpPr>
            <p:spPr>
              <a:xfrm>
                <a:off x="9773348" y="3651860"/>
                <a:ext cx="1291491" cy="180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Plasma Cells</a:t>
                </a:r>
                <a:endParaRPr lang="el-GR" sz="1200" dirty="0"/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2D7135F-F1CA-77AF-E960-8514F5D02683}"/>
                  </a:ext>
                </a:extLst>
              </p:cNvPr>
              <p:cNvSpPr txBox="1"/>
              <p:nvPr/>
            </p:nvSpPr>
            <p:spPr>
              <a:xfrm>
                <a:off x="9771442" y="3476603"/>
                <a:ext cx="1291491" cy="216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Myeloid</a:t>
                </a:r>
                <a:endParaRPr lang="el-GR" sz="1200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BBE9B7E8-25D1-D9A5-4709-F3BCDBF39375}"/>
                  </a:ext>
                </a:extLst>
              </p:cNvPr>
              <p:cNvSpPr txBox="1"/>
              <p:nvPr/>
            </p:nvSpPr>
            <p:spPr>
              <a:xfrm>
                <a:off x="9767486" y="3301298"/>
                <a:ext cx="923736" cy="180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Mast Cells</a:t>
                </a:r>
                <a:endParaRPr lang="el-GR" sz="1200" dirty="0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A083FA36-C3CB-C886-8E7E-F869B90D3A87}"/>
                  </a:ext>
                </a:extLst>
              </p:cNvPr>
              <p:cNvSpPr txBox="1"/>
              <p:nvPr/>
            </p:nvSpPr>
            <p:spPr>
              <a:xfrm>
                <a:off x="9771216" y="3116836"/>
                <a:ext cx="1291491" cy="216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Ciliated cells</a:t>
                </a:r>
                <a:endParaRPr lang="el-GR" sz="1200" dirty="0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6E56873E-AA4F-0924-DD1B-59AF1BE4724C}"/>
                  </a:ext>
                </a:extLst>
              </p:cNvPr>
              <p:cNvSpPr txBox="1"/>
              <p:nvPr/>
            </p:nvSpPr>
            <p:spPr>
              <a:xfrm>
                <a:off x="9768038" y="2950562"/>
                <a:ext cx="727892" cy="180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CAFs</a:t>
                </a:r>
                <a:endParaRPr lang="el-GR" sz="1200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0F9C224-AF01-8CCF-AD57-C01C26E1BF3B}"/>
                  </a:ext>
                </a:extLst>
              </p:cNvPr>
              <p:cNvSpPr txBox="1"/>
              <p:nvPr/>
            </p:nvSpPr>
            <p:spPr>
              <a:xfrm>
                <a:off x="9771216" y="2780729"/>
                <a:ext cx="1539750" cy="180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B cells</a:t>
                </a:r>
                <a:endParaRPr lang="el-GR" sz="1200" dirty="0"/>
              </a:p>
            </p:txBody>
          </p:sp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067CB4A-9C26-DC72-6F3C-1736918A4080}"/>
                </a:ext>
              </a:extLst>
            </p:cNvPr>
            <p:cNvSpPr txBox="1"/>
            <p:nvPr/>
          </p:nvSpPr>
          <p:spPr>
            <a:xfrm>
              <a:off x="2122748" y="113914"/>
              <a:ext cx="3973251" cy="288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b="1" i="1" dirty="0"/>
                <a:t>TCF7</a:t>
              </a:r>
              <a:r>
                <a:rPr lang="en-US" sz="1600" b="1" dirty="0"/>
                <a:t> expression per cell subset</a:t>
              </a:r>
              <a:endParaRPr lang="el-GR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270756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" name="Ευθεία γραμμή σύνδεσης 12">
            <a:extLst>
              <a:ext uri="{FF2B5EF4-FFF2-40B4-BE49-F238E27FC236}">
                <a16:creationId xmlns:a16="http://schemas.microsoft.com/office/drawing/2014/main" id="{A4283DD1-0046-2ACE-279D-13F790091DD9}"/>
              </a:ext>
            </a:extLst>
          </p:cNvPr>
          <p:cNvCxnSpPr/>
          <p:nvPr/>
        </p:nvCxnSpPr>
        <p:spPr>
          <a:xfrm>
            <a:off x="424542" y="7020990"/>
            <a:ext cx="1138645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F089D3A7-9460-0073-2EC5-9FA5871E7F57}"/>
              </a:ext>
            </a:extLst>
          </p:cNvPr>
          <p:cNvSpPr txBox="1"/>
          <p:nvPr/>
        </p:nvSpPr>
        <p:spPr>
          <a:xfrm>
            <a:off x="1479268" y="255795"/>
            <a:ext cx="65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l-GR" b="1" dirty="0"/>
          </a:p>
        </p:txBody>
      </p:sp>
      <p:cxnSp>
        <p:nvCxnSpPr>
          <p:cNvPr id="20" name="Ευθεία γραμμή σύνδεσης 19">
            <a:extLst>
              <a:ext uri="{FF2B5EF4-FFF2-40B4-BE49-F238E27FC236}">
                <a16:creationId xmlns:a16="http://schemas.microsoft.com/office/drawing/2014/main" id="{30BA7A59-0EE9-066C-5122-3B479F51A6C0}"/>
              </a:ext>
            </a:extLst>
          </p:cNvPr>
          <p:cNvCxnSpPr/>
          <p:nvPr/>
        </p:nvCxnSpPr>
        <p:spPr>
          <a:xfrm>
            <a:off x="424542" y="7020990"/>
            <a:ext cx="11386457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1" name="Ομάδα 20">
            <a:extLst>
              <a:ext uri="{FF2B5EF4-FFF2-40B4-BE49-F238E27FC236}">
                <a16:creationId xmlns:a16="http://schemas.microsoft.com/office/drawing/2014/main" id="{A5B2484B-7229-3535-B03C-2120DA4217D9}"/>
              </a:ext>
            </a:extLst>
          </p:cNvPr>
          <p:cNvGrpSpPr/>
          <p:nvPr/>
        </p:nvGrpSpPr>
        <p:grpSpPr>
          <a:xfrm>
            <a:off x="1740953" y="421248"/>
            <a:ext cx="9601962" cy="6352066"/>
            <a:chOff x="1740953" y="421248"/>
            <a:chExt cx="9601962" cy="6352066"/>
          </a:xfrm>
        </p:grpSpPr>
        <p:pic>
          <p:nvPicPr>
            <p:cNvPr id="22" name="Εικόνα 21" descr="Εικόνα που περιέχει κείμενο, στιγμιότυπο οθόνης, γράφημα, διάγραμμα&#10;&#10;Το περιεχόμενο που δημιουργείται από AI ενδέχεται να είναι εσφαλμένο.">
              <a:extLst>
                <a:ext uri="{FF2B5EF4-FFF2-40B4-BE49-F238E27FC236}">
                  <a16:creationId xmlns:a16="http://schemas.microsoft.com/office/drawing/2014/main" id="{B9107D0E-C0AC-E5DB-FC92-67DC6510FC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04388" y="421248"/>
              <a:ext cx="8690936" cy="5941861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BE5496C-A044-E9E5-BBF6-95AD8403A454}"/>
                </a:ext>
              </a:extLst>
            </p:cNvPr>
            <p:cNvSpPr txBox="1"/>
            <p:nvPr/>
          </p:nvSpPr>
          <p:spPr>
            <a:xfrm>
              <a:off x="2248320" y="6146987"/>
              <a:ext cx="104109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B cells</a:t>
              </a:r>
              <a:endParaRPr lang="el-GR" sz="12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07A3630-B3BC-75CA-5021-0F2623C74352}"/>
                </a:ext>
              </a:extLst>
            </p:cNvPr>
            <p:cNvSpPr txBox="1"/>
            <p:nvPr/>
          </p:nvSpPr>
          <p:spPr>
            <a:xfrm>
              <a:off x="8070687" y="6145251"/>
              <a:ext cx="78911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 cells</a:t>
              </a:r>
              <a:endParaRPr lang="el-GR" sz="12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B012A17-FC85-C3ED-2F8E-55C7855E2AB7}"/>
                </a:ext>
              </a:extLst>
            </p:cNvPr>
            <p:cNvSpPr txBox="1"/>
            <p:nvPr/>
          </p:nvSpPr>
          <p:spPr>
            <a:xfrm>
              <a:off x="3247855" y="6148468"/>
              <a:ext cx="78911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CAFs</a:t>
              </a:r>
              <a:endParaRPr lang="el-GR" sz="12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2D5993C-BB75-61B3-A4D9-D7F4B0E3A890}"/>
                </a:ext>
              </a:extLst>
            </p:cNvPr>
            <p:cNvSpPr txBox="1"/>
            <p:nvPr/>
          </p:nvSpPr>
          <p:spPr>
            <a:xfrm>
              <a:off x="5016662" y="6155662"/>
              <a:ext cx="10440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Mast Cells</a:t>
              </a:r>
              <a:endParaRPr lang="el-GR" sz="12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608312D-5F3C-2E60-CBB6-D964225ED2A4}"/>
                </a:ext>
              </a:extLst>
            </p:cNvPr>
            <p:cNvSpPr txBox="1"/>
            <p:nvPr/>
          </p:nvSpPr>
          <p:spPr>
            <a:xfrm>
              <a:off x="5129313" y="6465537"/>
              <a:ext cx="84268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Identity</a:t>
              </a:r>
              <a:endParaRPr lang="el-GR" sz="1400" b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6F81E79-106F-9E9E-0C24-23F334ABC6A7}"/>
                </a:ext>
              </a:extLst>
            </p:cNvPr>
            <p:cNvSpPr txBox="1"/>
            <p:nvPr/>
          </p:nvSpPr>
          <p:spPr>
            <a:xfrm rot="16200000">
              <a:off x="1039607" y="3063548"/>
              <a:ext cx="171046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Expression Level</a:t>
              </a:r>
              <a:endParaRPr lang="el-GR" sz="1400" b="1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CDB915F-B662-3C7D-F229-880C27E4A23D}"/>
                </a:ext>
              </a:extLst>
            </p:cNvPr>
            <p:cNvSpPr txBox="1"/>
            <p:nvPr/>
          </p:nvSpPr>
          <p:spPr>
            <a:xfrm>
              <a:off x="6010179" y="6157498"/>
              <a:ext cx="111650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Myeloid</a:t>
              </a:r>
              <a:endParaRPr lang="el-GR" sz="12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3A921FE-FA08-2D14-D66F-E2AD1754097A}"/>
                </a:ext>
              </a:extLst>
            </p:cNvPr>
            <p:cNvSpPr txBox="1"/>
            <p:nvPr/>
          </p:nvSpPr>
          <p:spPr>
            <a:xfrm>
              <a:off x="4121313" y="6145252"/>
              <a:ext cx="100800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Ciliated cells</a:t>
              </a:r>
              <a:endParaRPr lang="el-GR" sz="12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7918C94-A425-87FD-FB1B-57DE96AE1908}"/>
                </a:ext>
              </a:extLst>
            </p:cNvPr>
            <p:cNvSpPr txBox="1"/>
            <p:nvPr/>
          </p:nvSpPr>
          <p:spPr>
            <a:xfrm>
              <a:off x="6906446" y="6155661"/>
              <a:ext cx="122014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lasma Cells</a:t>
              </a:r>
              <a:endParaRPr lang="el-GR" sz="12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C61713E-6E94-53E9-C765-D04E86E77FF0}"/>
                </a:ext>
              </a:extLst>
            </p:cNvPr>
            <p:cNvSpPr txBox="1"/>
            <p:nvPr/>
          </p:nvSpPr>
          <p:spPr>
            <a:xfrm>
              <a:off x="9318137" y="3454295"/>
              <a:ext cx="1622006" cy="180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UNK</a:t>
              </a:r>
              <a:endParaRPr lang="el-GR" sz="12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CD6C70E-9E27-C688-25A8-896752C59386}"/>
                </a:ext>
              </a:extLst>
            </p:cNvPr>
            <p:cNvSpPr txBox="1"/>
            <p:nvPr/>
          </p:nvSpPr>
          <p:spPr>
            <a:xfrm>
              <a:off x="9318136" y="3290537"/>
              <a:ext cx="2024779" cy="25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quamous cell carcinoma </a:t>
              </a:r>
              <a:endParaRPr lang="el-GR" sz="1200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698CBF4-CE6B-9A5A-FD63-EE830069DE8B}"/>
                </a:ext>
              </a:extLst>
            </p:cNvPr>
            <p:cNvSpPr txBox="1"/>
            <p:nvPr/>
          </p:nvSpPr>
          <p:spPr>
            <a:xfrm>
              <a:off x="9307251" y="3113299"/>
              <a:ext cx="162200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adenoacarcinoma</a:t>
              </a:r>
              <a:endParaRPr lang="el-GR" sz="1200" dirty="0"/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3E6E3F0C-799A-A67E-9665-8EE57F9A4DB8}"/>
              </a:ext>
            </a:extLst>
          </p:cNvPr>
          <p:cNvSpPr txBox="1"/>
          <p:nvPr/>
        </p:nvSpPr>
        <p:spPr>
          <a:xfrm>
            <a:off x="2107963" y="334471"/>
            <a:ext cx="397325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i="1" dirty="0"/>
              <a:t>TCF7</a:t>
            </a:r>
            <a:r>
              <a:rPr lang="en-US" sz="1600" b="1" dirty="0"/>
              <a:t> expression per NSCLC subtype</a:t>
            </a:r>
            <a:endParaRPr lang="el-GR" sz="1600" b="1" dirty="0"/>
          </a:p>
        </p:txBody>
      </p:sp>
    </p:spTree>
    <p:extLst>
      <p:ext uri="{BB962C8B-B14F-4D97-AF65-F5344CB8AC3E}">
        <p14:creationId xmlns:p14="http://schemas.microsoft.com/office/powerpoint/2010/main" val="395663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Εικόνα 6" descr="Εικόνα που περιέχει κείμενο, χάρτης, διάγραμμα&#10;&#10;Το περιεχόμενο που δημιουργείται από AI ενδέχεται να είναι εσφαλμένο.">
            <a:extLst>
              <a:ext uri="{FF2B5EF4-FFF2-40B4-BE49-F238E27FC236}">
                <a16:creationId xmlns:a16="http://schemas.microsoft.com/office/drawing/2014/main" id="{E7149C14-87A4-A2B0-8310-7E48B3C5F2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6821" y="0"/>
            <a:ext cx="9798357" cy="6858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93C24D5-FB66-7814-62F6-A4EB6F4179DF}"/>
              </a:ext>
            </a:extLst>
          </p:cNvPr>
          <p:cNvSpPr txBox="1"/>
          <p:nvPr/>
        </p:nvSpPr>
        <p:spPr>
          <a:xfrm>
            <a:off x="960601" y="-54430"/>
            <a:ext cx="65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  <a:endParaRPr lang="el-GR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61A4B3-74A2-A67E-D843-14177725F758}"/>
              </a:ext>
            </a:extLst>
          </p:cNvPr>
          <p:cNvSpPr txBox="1"/>
          <p:nvPr/>
        </p:nvSpPr>
        <p:spPr>
          <a:xfrm>
            <a:off x="1703085" y="32658"/>
            <a:ext cx="450177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/>
              <a:t>UMAP - </a:t>
            </a:r>
            <a:r>
              <a:rPr lang="en-US" sz="1600" b="1" i="1" dirty="0"/>
              <a:t>TCF7</a:t>
            </a:r>
            <a:r>
              <a:rPr lang="en-US" sz="1600" b="1" dirty="0"/>
              <a:t> expression per cell subset</a:t>
            </a:r>
            <a:endParaRPr lang="el-GR" sz="1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0D4908-5A91-C5F6-C479-DF7C6576132F}"/>
              </a:ext>
            </a:extLst>
          </p:cNvPr>
          <p:cNvSpPr txBox="1"/>
          <p:nvPr/>
        </p:nvSpPr>
        <p:spPr>
          <a:xfrm rot="16200000">
            <a:off x="495475" y="3275111"/>
            <a:ext cx="171046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umaprpca_2</a:t>
            </a:r>
            <a:endParaRPr lang="el-GR" sz="14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1D496E-19AC-ADCB-B3AF-8C44B164485F}"/>
              </a:ext>
            </a:extLst>
          </p:cNvPr>
          <p:cNvSpPr txBox="1"/>
          <p:nvPr/>
        </p:nvSpPr>
        <p:spPr>
          <a:xfrm>
            <a:off x="5240764" y="6528451"/>
            <a:ext cx="171046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umaprpca_1</a:t>
            </a:r>
            <a:endParaRPr lang="el-GR" sz="1400" b="1" dirty="0"/>
          </a:p>
        </p:txBody>
      </p:sp>
    </p:spTree>
    <p:extLst>
      <p:ext uri="{BB962C8B-B14F-4D97-AF65-F5344CB8AC3E}">
        <p14:creationId xmlns:p14="http://schemas.microsoft.com/office/powerpoint/2010/main" val="22428181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4B32C05-BE6C-513E-E70A-73D2162D259D}"/>
              </a:ext>
            </a:extLst>
          </p:cNvPr>
          <p:cNvSpPr txBox="1"/>
          <p:nvPr/>
        </p:nvSpPr>
        <p:spPr>
          <a:xfrm>
            <a:off x="957237" y="22388"/>
            <a:ext cx="65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  <a:endParaRPr lang="el-GR" b="1" dirty="0"/>
          </a:p>
        </p:txBody>
      </p:sp>
      <p:grpSp>
        <p:nvGrpSpPr>
          <p:cNvPr id="16" name="Ομάδα 15">
            <a:extLst>
              <a:ext uri="{FF2B5EF4-FFF2-40B4-BE49-F238E27FC236}">
                <a16:creationId xmlns:a16="http://schemas.microsoft.com/office/drawing/2014/main" id="{08613F75-9D14-89F7-C86E-C5C6FB0DF235}"/>
              </a:ext>
            </a:extLst>
          </p:cNvPr>
          <p:cNvGrpSpPr/>
          <p:nvPr/>
        </p:nvGrpSpPr>
        <p:grpSpPr>
          <a:xfrm>
            <a:off x="1282357" y="92147"/>
            <a:ext cx="10178123" cy="6740306"/>
            <a:chOff x="1282357" y="168347"/>
            <a:chExt cx="10178123" cy="6740306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CCBBE41-D02C-6465-F9BF-3C14605A5210}"/>
                </a:ext>
              </a:extLst>
            </p:cNvPr>
            <p:cNvSpPr txBox="1"/>
            <p:nvPr/>
          </p:nvSpPr>
          <p:spPr>
            <a:xfrm>
              <a:off x="4920659" y="6600876"/>
              <a:ext cx="83065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Identity</a:t>
              </a:r>
              <a:endParaRPr lang="el-GR" sz="1400" b="1" dirty="0"/>
            </a:p>
          </p:txBody>
        </p:sp>
        <p:grpSp>
          <p:nvGrpSpPr>
            <p:cNvPr id="18" name="Ομάδα 17">
              <a:extLst>
                <a:ext uri="{FF2B5EF4-FFF2-40B4-BE49-F238E27FC236}">
                  <a16:creationId xmlns:a16="http://schemas.microsoft.com/office/drawing/2014/main" id="{E121CF0E-AA47-C1D0-6611-EAE8822EA49C}"/>
                </a:ext>
              </a:extLst>
            </p:cNvPr>
            <p:cNvGrpSpPr/>
            <p:nvPr/>
          </p:nvGrpSpPr>
          <p:grpSpPr>
            <a:xfrm>
              <a:off x="1282357" y="217423"/>
              <a:ext cx="10178123" cy="6384595"/>
              <a:chOff x="1180414" y="51916"/>
              <a:chExt cx="10908413" cy="6911782"/>
            </a:xfrm>
          </p:grpSpPr>
          <p:pic>
            <p:nvPicPr>
              <p:cNvPr id="20" name="Εικόνα 19" descr="Εικόνα που περιέχει κείμενο, διάγραμμα, γράφημα, στιγμιότυπο οθόνης&#10;&#10;Το περιεχόμενο που δημιουργείται από AI ενδέχεται να είναι εσφαλμένο.">
                <a:extLst>
                  <a:ext uri="{FF2B5EF4-FFF2-40B4-BE49-F238E27FC236}">
                    <a16:creationId xmlns:a16="http://schemas.microsoft.com/office/drawing/2014/main" id="{D4388CF3-D73E-BE35-909E-1588F27F5B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180414" y="51916"/>
                <a:ext cx="9831172" cy="6754168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B95F95F-CED8-4775-6206-0C9CB052CDCA}"/>
                  </a:ext>
                </a:extLst>
              </p:cNvPr>
              <p:cNvSpPr txBox="1"/>
              <p:nvPr/>
            </p:nvSpPr>
            <p:spPr>
              <a:xfrm>
                <a:off x="1912741" y="6460939"/>
                <a:ext cx="775343" cy="4997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CD4+ T cells</a:t>
                </a:r>
                <a:endParaRPr lang="el-GR" sz="12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784E162-609C-5417-7BD8-96167CDB1676}"/>
                  </a:ext>
                </a:extLst>
              </p:cNvPr>
              <p:cNvSpPr txBox="1"/>
              <p:nvPr/>
            </p:nvSpPr>
            <p:spPr>
              <a:xfrm>
                <a:off x="8319060" y="6471825"/>
                <a:ext cx="890254" cy="29987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Treg cells</a:t>
                </a:r>
                <a:endParaRPr lang="el-GR" sz="1200" dirty="0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A423598-1495-5AE0-C1DD-F3A66FF05919}"/>
                  </a:ext>
                </a:extLst>
              </p:cNvPr>
              <p:cNvSpPr txBox="1"/>
              <p:nvPr/>
            </p:nvSpPr>
            <p:spPr>
              <a:xfrm>
                <a:off x="3015455" y="6463912"/>
                <a:ext cx="739312" cy="4997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CD8+ T cells</a:t>
                </a:r>
                <a:endParaRPr lang="el-GR" sz="1200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DB81D81-007A-2B36-2734-3A305141C3B4}"/>
                  </a:ext>
                </a:extLst>
              </p:cNvPr>
              <p:cNvSpPr txBox="1"/>
              <p:nvPr/>
            </p:nvSpPr>
            <p:spPr>
              <a:xfrm>
                <a:off x="3791585" y="6460939"/>
                <a:ext cx="1268098" cy="4997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Follicular Helper T cells</a:t>
                </a:r>
                <a:endParaRPr lang="el-GR" sz="12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00B97A6E-31A2-6D4E-1267-E62A9BC5A67C}"/>
                  </a:ext>
                </a:extLst>
              </p:cNvPr>
              <p:cNvSpPr txBox="1"/>
              <p:nvPr/>
            </p:nvSpPr>
            <p:spPr>
              <a:xfrm>
                <a:off x="4959858" y="6463561"/>
                <a:ext cx="1080325" cy="49978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Memory/GC B cells</a:t>
                </a:r>
                <a:endParaRPr lang="el-GR" sz="1200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F97A256-70A5-E89F-7D68-EFD7EFC359F0}"/>
                  </a:ext>
                </a:extLst>
              </p:cNvPr>
              <p:cNvSpPr txBox="1"/>
              <p:nvPr/>
            </p:nvSpPr>
            <p:spPr>
              <a:xfrm>
                <a:off x="9741513" y="2650938"/>
                <a:ext cx="1520209" cy="1948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CD4+ T cells</a:t>
                </a:r>
                <a:endParaRPr lang="el-GR" sz="1200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0C5DAE2-8151-8933-F514-BC679AFBF3BB}"/>
                  </a:ext>
                </a:extLst>
              </p:cNvPr>
              <p:cNvSpPr txBox="1"/>
              <p:nvPr/>
            </p:nvSpPr>
            <p:spPr>
              <a:xfrm>
                <a:off x="9744065" y="2875056"/>
                <a:ext cx="1520209" cy="1948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CD8+ T cells</a:t>
                </a:r>
                <a:endParaRPr lang="el-GR" sz="1200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1661B1A1-12D8-9CA4-0F2D-908BE2A0F0CF}"/>
                  </a:ext>
                </a:extLst>
              </p:cNvPr>
              <p:cNvSpPr txBox="1"/>
              <p:nvPr/>
            </p:nvSpPr>
            <p:spPr>
              <a:xfrm>
                <a:off x="9756004" y="3101691"/>
                <a:ext cx="2019582" cy="1948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Follicular Helper T cells</a:t>
                </a:r>
                <a:endParaRPr lang="el-GR" sz="1200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219DF5C6-1B6B-F414-A66D-11A3A35CBDFC}"/>
                  </a:ext>
                </a:extLst>
              </p:cNvPr>
              <p:cNvSpPr txBox="1"/>
              <p:nvPr/>
            </p:nvSpPr>
            <p:spPr>
              <a:xfrm>
                <a:off x="9752191" y="3306350"/>
                <a:ext cx="2019582" cy="1948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Memory/GC B cells</a:t>
                </a:r>
                <a:endParaRPr lang="el-GR" sz="1200" dirty="0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014026B0-476B-517C-7EDD-692C40B42F23}"/>
                  </a:ext>
                </a:extLst>
              </p:cNvPr>
              <p:cNvSpPr txBox="1"/>
              <p:nvPr/>
            </p:nvSpPr>
            <p:spPr>
              <a:xfrm>
                <a:off x="9759899" y="3530771"/>
                <a:ext cx="2328928" cy="23383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Naive/Transitional B cells</a:t>
                </a:r>
                <a:endParaRPr lang="el-GR" sz="1200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D22EB925-475B-B7AF-D4FD-2C250D4F402C}"/>
                  </a:ext>
                </a:extLst>
              </p:cNvPr>
              <p:cNvSpPr txBox="1"/>
              <p:nvPr/>
            </p:nvSpPr>
            <p:spPr>
              <a:xfrm>
                <a:off x="9750621" y="3757981"/>
                <a:ext cx="1275101" cy="27280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Plasma Cells</a:t>
                </a:r>
                <a:endParaRPr lang="el-GR" sz="1200" dirty="0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C1D5B40-CCD1-5D31-1EC2-CF757EFD8D87}"/>
                  </a:ext>
                </a:extLst>
              </p:cNvPr>
              <p:cNvSpPr txBox="1"/>
              <p:nvPr/>
            </p:nvSpPr>
            <p:spPr>
              <a:xfrm>
                <a:off x="9755733" y="3956461"/>
                <a:ext cx="1006492" cy="23383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Treg cells</a:t>
                </a:r>
                <a:endParaRPr lang="el-GR" sz="120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24238712-04D7-F0C0-08F6-8AFFADC79574}"/>
                  </a:ext>
                </a:extLst>
              </p:cNvPr>
              <p:cNvSpPr txBox="1"/>
              <p:nvPr/>
            </p:nvSpPr>
            <p:spPr>
              <a:xfrm rot="16200000">
                <a:off x="541475" y="3098563"/>
                <a:ext cx="1700846" cy="32986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/>
                  <a:t>Expression Level</a:t>
                </a:r>
                <a:endParaRPr lang="el-GR" sz="1400" b="1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0352BD4-8001-B1DC-E32C-3308E2ED94E4}"/>
                  </a:ext>
                </a:extLst>
              </p:cNvPr>
              <p:cNvSpPr txBox="1"/>
              <p:nvPr/>
            </p:nvSpPr>
            <p:spPr>
              <a:xfrm>
                <a:off x="7287454" y="6449827"/>
                <a:ext cx="848827" cy="49978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Plasma Cells</a:t>
                </a:r>
                <a:endParaRPr lang="el-GR" sz="1200" dirty="0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42EF533B-074A-0C78-DB95-C7F72561450F}"/>
                  </a:ext>
                </a:extLst>
              </p:cNvPr>
              <p:cNvSpPr txBox="1"/>
              <p:nvPr/>
            </p:nvSpPr>
            <p:spPr>
              <a:xfrm>
                <a:off x="5910913" y="6452713"/>
                <a:ext cx="1504738" cy="49978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Naive/Transitional </a:t>
                </a:r>
              </a:p>
              <a:p>
                <a:pPr algn="ctr"/>
                <a:r>
                  <a:rPr lang="en-US" sz="1200" dirty="0"/>
                  <a:t>B cells</a:t>
                </a:r>
                <a:endParaRPr lang="el-GR" sz="1200" dirty="0"/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514A292-81DB-8360-4923-9B5E16B6E24A}"/>
                </a:ext>
              </a:extLst>
            </p:cNvPr>
            <p:cNvSpPr txBox="1"/>
            <p:nvPr/>
          </p:nvSpPr>
          <p:spPr>
            <a:xfrm>
              <a:off x="1682213" y="168347"/>
              <a:ext cx="3973251" cy="360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b="1" i="1" dirty="0"/>
                <a:t>TCF7</a:t>
              </a:r>
              <a:r>
                <a:rPr lang="en-US" sz="1600" b="1" dirty="0"/>
                <a:t> expression per cell subset</a:t>
              </a:r>
              <a:endParaRPr lang="el-GR" sz="1600" b="1" dirty="0"/>
            </a:p>
            <a:p>
              <a:endParaRPr lang="el-GR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442122436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43</TotalTime>
  <Words>135</Words>
  <Application>Microsoft Office PowerPoint</Application>
  <PresentationFormat>Ευρεία οθόνη</PresentationFormat>
  <Paragraphs>56</Paragraphs>
  <Slides>4</Slides>
  <Notes>1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Θέμα του Offic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annis Pateras</dc:creator>
  <cp:lastModifiedBy>Ioannis Pateras</cp:lastModifiedBy>
  <cp:revision>45</cp:revision>
  <dcterms:created xsi:type="dcterms:W3CDTF">2025-06-17T20:16:32Z</dcterms:created>
  <dcterms:modified xsi:type="dcterms:W3CDTF">2026-01-18T13:24:17Z</dcterms:modified>
</cp:coreProperties>
</file>